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6B413"/>
    <a:srgbClr val="1056FD"/>
    <a:srgbClr val="EE1A31"/>
    <a:srgbClr val="F3556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>
        <p:scale>
          <a:sx n="100" d="100"/>
          <a:sy n="100" d="100"/>
        </p:scale>
        <p:origin x="9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CFC98-9559-4EA7-89C1-F794E30F4F1E}" type="datetimeFigureOut">
              <a:rPr kumimoji="1" lang="ja-JP" altLang="en-US" smtClean="0"/>
              <a:t>2019/12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9A771-931F-442A-B3D1-20EA2526AA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91573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CFC98-9559-4EA7-89C1-F794E30F4F1E}" type="datetimeFigureOut">
              <a:rPr kumimoji="1" lang="ja-JP" altLang="en-US" smtClean="0"/>
              <a:t>2019/12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9A771-931F-442A-B3D1-20EA2526AA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7519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CFC98-9559-4EA7-89C1-F794E30F4F1E}" type="datetimeFigureOut">
              <a:rPr kumimoji="1" lang="ja-JP" altLang="en-US" smtClean="0"/>
              <a:t>2019/12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9A771-931F-442A-B3D1-20EA2526AA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44221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CFC98-9559-4EA7-89C1-F794E30F4F1E}" type="datetimeFigureOut">
              <a:rPr kumimoji="1" lang="ja-JP" altLang="en-US" smtClean="0"/>
              <a:t>2019/12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9A771-931F-442A-B3D1-20EA2526AA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60270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CFC98-9559-4EA7-89C1-F794E30F4F1E}" type="datetimeFigureOut">
              <a:rPr kumimoji="1" lang="ja-JP" altLang="en-US" smtClean="0"/>
              <a:t>2019/12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9A771-931F-442A-B3D1-20EA2526AA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86093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CFC98-9559-4EA7-89C1-F794E30F4F1E}" type="datetimeFigureOut">
              <a:rPr kumimoji="1" lang="ja-JP" altLang="en-US" smtClean="0"/>
              <a:t>2019/12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9A771-931F-442A-B3D1-20EA2526AA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51409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CFC98-9559-4EA7-89C1-F794E30F4F1E}" type="datetimeFigureOut">
              <a:rPr kumimoji="1" lang="ja-JP" altLang="en-US" smtClean="0"/>
              <a:t>2019/12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9A771-931F-442A-B3D1-20EA2526AA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07162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CFC98-9559-4EA7-89C1-F794E30F4F1E}" type="datetimeFigureOut">
              <a:rPr kumimoji="1" lang="ja-JP" altLang="en-US" smtClean="0"/>
              <a:t>2019/12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9A771-931F-442A-B3D1-20EA2526AA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8053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CFC98-9559-4EA7-89C1-F794E30F4F1E}" type="datetimeFigureOut">
              <a:rPr kumimoji="1" lang="ja-JP" altLang="en-US" smtClean="0"/>
              <a:t>2019/12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9A771-931F-442A-B3D1-20EA2526AA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4026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CFC98-9559-4EA7-89C1-F794E30F4F1E}" type="datetimeFigureOut">
              <a:rPr kumimoji="1" lang="ja-JP" altLang="en-US" smtClean="0"/>
              <a:t>2019/12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9A771-931F-442A-B3D1-20EA2526AA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73917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CFC98-9559-4EA7-89C1-F794E30F4F1E}" type="datetimeFigureOut">
              <a:rPr kumimoji="1" lang="ja-JP" altLang="en-US" smtClean="0"/>
              <a:t>2019/12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9A771-931F-442A-B3D1-20EA2526AA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78213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7CFC98-9559-4EA7-89C1-F794E30F4F1E}" type="datetimeFigureOut">
              <a:rPr kumimoji="1" lang="ja-JP" altLang="en-US" smtClean="0"/>
              <a:t>2019/12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B9A771-931F-442A-B3D1-20EA2526AA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3467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8" name="図 157">
            <a:extLst>
              <a:ext uri="{FF2B5EF4-FFF2-40B4-BE49-F238E27FC236}">
                <a16:creationId xmlns:a16="http://schemas.microsoft.com/office/drawing/2014/main" id="{7EF81BAE-9982-49EA-9B9B-B651F383B1E1}"/>
              </a:ext>
            </a:extLst>
          </p:cNvPr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598" y="3169872"/>
            <a:ext cx="2448000" cy="1656000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id="{2535E006-65EA-4892-957D-8C0E60EBE3D4}"/>
              </a:ext>
            </a:extLst>
          </p:cNvPr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1048" y="579009"/>
            <a:ext cx="2448000" cy="1656000"/>
          </a:xfrm>
          <a:prstGeom prst="rect">
            <a:avLst/>
          </a:prstGeom>
        </p:spPr>
      </p:pic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0D68B969-7AE6-4E48-9292-AFFF7EBE4B76}"/>
              </a:ext>
            </a:extLst>
          </p:cNvPr>
          <p:cNvGrpSpPr/>
          <p:nvPr/>
        </p:nvGrpSpPr>
        <p:grpSpPr>
          <a:xfrm>
            <a:off x="144116" y="326252"/>
            <a:ext cx="3011780" cy="2204164"/>
            <a:chOff x="144116" y="326252"/>
            <a:chExt cx="3011780" cy="2204164"/>
          </a:xfrm>
        </p:grpSpPr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5D18C867-5C1E-439B-BDEA-0963127F16DC}"/>
                </a:ext>
              </a:extLst>
            </p:cNvPr>
            <p:cNvPicPr>
              <a:picLocks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6164" y="579009"/>
              <a:ext cx="2448000" cy="1656000"/>
            </a:xfrm>
            <a:prstGeom prst="rect">
              <a:avLst/>
            </a:prstGeom>
          </p:spPr>
        </p:pic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68A9C66A-D162-43ED-98A1-E2CA5AE5BD38}"/>
                </a:ext>
              </a:extLst>
            </p:cNvPr>
            <p:cNvSpPr txBox="1"/>
            <p:nvPr/>
          </p:nvSpPr>
          <p:spPr>
            <a:xfrm>
              <a:off x="266919" y="326252"/>
              <a:ext cx="3097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093B50C7-577B-4EEB-A5D2-D880159BE4CF}"/>
                </a:ext>
              </a:extLst>
            </p:cNvPr>
            <p:cNvSpPr txBox="1"/>
            <p:nvPr/>
          </p:nvSpPr>
          <p:spPr>
            <a:xfrm>
              <a:off x="1265558" y="810265"/>
              <a:ext cx="18809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ALI </a:t>
              </a:r>
              <a:r>
                <a: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≥ 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8 (n = 161): 4.4 (3.3-5.6) 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C6C4333B-9A7E-4D03-857D-963A2303839B}"/>
                </a:ext>
              </a:extLst>
            </p:cNvPr>
            <p:cNvSpPr txBox="1"/>
            <p:nvPr/>
          </p:nvSpPr>
          <p:spPr>
            <a:xfrm>
              <a:off x="1274934" y="980840"/>
              <a:ext cx="18809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ALI &lt; 18 (n = 122): 1.7 (1.3-3.0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9847C91D-694B-4A25-941E-B5F740D17654}"/>
                </a:ext>
              </a:extLst>
            </p:cNvPr>
            <p:cNvSpPr txBox="1"/>
            <p:nvPr/>
          </p:nvSpPr>
          <p:spPr>
            <a:xfrm>
              <a:off x="1938903" y="629064"/>
              <a:ext cx="11178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Months (95% CI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B5D628B1-CC63-46E7-A263-AAD196B086F2}"/>
                </a:ext>
              </a:extLst>
            </p:cNvPr>
            <p:cNvSpPr txBox="1"/>
            <p:nvPr/>
          </p:nvSpPr>
          <p:spPr>
            <a:xfrm>
              <a:off x="1304803" y="1159551"/>
              <a:ext cx="11002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p &lt; 0.00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CFABD434-1E6D-441F-8B72-AFC4BC8DFAD7}"/>
                </a:ext>
              </a:extLst>
            </p:cNvPr>
            <p:cNvSpPr txBox="1"/>
            <p:nvPr/>
          </p:nvSpPr>
          <p:spPr>
            <a:xfrm rot="16200000">
              <a:off x="-420782" y="1304772"/>
              <a:ext cx="13452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Survival (PFS) probability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308DE828-DF0C-42D1-A12E-6F76AA7A0AD1}"/>
                </a:ext>
              </a:extLst>
            </p:cNvPr>
            <p:cNvSpPr txBox="1"/>
            <p:nvPr/>
          </p:nvSpPr>
          <p:spPr>
            <a:xfrm>
              <a:off x="250497" y="577076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3396D34A-2986-47E4-A093-1AAF0CB17001}"/>
                </a:ext>
              </a:extLst>
            </p:cNvPr>
            <p:cNvSpPr txBox="1"/>
            <p:nvPr/>
          </p:nvSpPr>
          <p:spPr>
            <a:xfrm>
              <a:off x="250497" y="873764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B685CDE1-6EDC-470B-926E-C80DB8CB3AF4}"/>
                </a:ext>
              </a:extLst>
            </p:cNvPr>
            <p:cNvSpPr txBox="1"/>
            <p:nvPr/>
          </p:nvSpPr>
          <p:spPr>
            <a:xfrm>
              <a:off x="250497" y="1170453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6A0BAFFD-EFA5-4A5B-9011-F0262C1C08BF}"/>
                </a:ext>
              </a:extLst>
            </p:cNvPr>
            <p:cNvSpPr txBox="1"/>
            <p:nvPr/>
          </p:nvSpPr>
          <p:spPr>
            <a:xfrm>
              <a:off x="250497" y="1467143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2BACDC07-ABFC-4895-9BC4-3DEF590B02E3}"/>
                </a:ext>
              </a:extLst>
            </p:cNvPr>
            <p:cNvSpPr txBox="1"/>
            <p:nvPr/>
          </p:nvSpPr>
          <p:spPr>
            <a:xfrm>
              <a:off x="250497" y="1763832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テキスト ボックス 94">
              <a:extLst>
                <a:ext uri="{FF2B5EF4-FFF2-40B4-BE49-F238E27FC236}">
                  <a16:creationId xmlns:a16="http://schemas.microsoft.com/office/drawing/2014/main" id="{1E35FA32-387D-4243-828C-B7E45DCD2792}"/>
                </a:ext>
              </a:extLst>
            </p:cNvPr>
            <p:cNvSpPr txBox="1"/>
            <p:nvPr/>
          </p:nvSpPr>
          <p:spPr>
            <a:xfrm>
              <a:off x="250497" y="2060520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テキスト ボックス 95">
              <a:extLst>
                <a:ext uri="{FF2B5EF4-FFF2-40B4-BE49-F238E27FC236}">
                  <a16:creationId xmlns:a16="http://schemas.microsoft.com/office/drawing/2014/main" id="{C14BD292-80FF-4208-844F-E5251E4BDCFD}"/>
                </a:ext>
              </a:extLst>
            </p:cNvPr>
            <p:cNvSpPr txBox="1"/>
            <p:nvPr/>
          </p:nvSpPr>
          <p:spPr>
            <a:xfrm>
              <a:off x="484817" y="219104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BA89B68F-1E97-4142-818C-AEC9CD7860B6}"/>
                </a:ext>
              </a:extLst>
            </p:cNvPr>
            <p:cNvSpPr txBox="1"/>
            <p:nvPr/>
          </p:nvSpPr>
          <p:spPr>
            <a:xfrm>
              <a:off x="1038932" y="219104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9D0DCF47-CC94-4D7A-A6E1-E7CC9076EDB4}"/>
                </a:ext>
              </a:extLst>
            </p:cNvPr>
            <p:cNvSpPr txBox="1"/>
            <p:nvPr/>
          </p:nvSpPr>
          <p:spPr>
            <a:xfrm>
              <a:off x="1626616" y="219104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F147DB4B-1059-4540-878C-A61CE1037F7F}"/>
                </a:ext>
              </a:extLst>
            </p:cNvPr>
            <p:cNvSpPr txBox="1"/>
            <p:nvPr/>
          </p:nvSpPr>
          <p:spPr>
            <a:xfrm>
              <a:off x="2214301" y="219104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2913F0B9-B44F-48CE-83DE-3908E969455A}"/>
                </a:ext>
              </a:extLst>
            </p:cNvPr>
            <p:cNvSpPr txBox="1"/>
            <p:nvPr/>
          </p:nvSpPr>
          <p:spPr>
            <a:xfrm>
              <a:off x="2508142" y="219104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906AE2B5-7B2E-41E0-BDC4-91D6AEB6C886}"/>
                </a:ext>
              </a:extLst>
            </p:cNvPr>
            <p:cNvSpPr txBox="1"/>
            <p:nvPr/>
          </p:nvSpPr>
          <p:spPr>
            <a:xfrm>
              <a:off x="2801988" y="2191042"/>
              <a:ext cx="3000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DBE1BA6E-E009-4DE9-B422-FC98BDDF34DE}"/>
                </a:ext>
              </a:extLst>
            </p:cNvPr>
            <p:cNvSpPr txBox="1"/>
            <p:nvPr/>
          </p:nvSpPr>
          <p:spPr>
            <a:xfrm>
              <a:off x="779496" y="219104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3550B0B7-1FF7-473F-8D0B-D503DEE5D667}"/>
                </a:ext>
              </a:extLst>
            </p:cNvPr>
            <p:cNvSpPr txBox="1"/>
            <p:nvPr/>
          </p:nvSpPr>
          <p:spPr>
            <a:xfrm>
              <a:off x="1332775" y="219104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8FF0CD8B-7555-41B7-962D-7B247C0C5D25}"/>
                </a:ext>
              </a:extLst>
            </p:cNvPr>
            <p:cNvSpPr txBox="1"/>
            <p:nvPr/>
          </p:nvSpPr>
          <p:spPr>
            <a:xfrm>
              <a:off x="1920459" y="219104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9F20EFE0-EE2F-44EC-885B-7AF4CD62F39D}"/>
                </a:ext>
              </a:extLst>
            </p:cNvPr>
            <p:cNvSpPr txBox="1"/>
            <p:nvPr/>
          </p:nvSpPr>
          <p:spPr>
            <a:xfrm>
              <a:off x="1265715" y="2314972"/>
              <a:ext cx="10347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Time (months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065DCA69-EFEB-46CF-98BB-42FCA7E1E8CD}"/>
                </a:ext>
              </a:extLst>
            </p:cNvPr>
            <p:cNvSpPr txBox="1"/>
            <p:nvPr/>
          </p:nvSpPr>
          <p:spPr>
            <a:xfrm>
              <a:off x="533013" y="326252"/>
              <a:ext cx="12094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All patients (n = 283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54DC570B-02D6-4BB6-8090-10D5F4433069}"/>
              </a:ext>
            </a:extLst>
          </p:cNvPr>
          <p:cNvSpPr txBox="1"/>
          <p:nvPr/>
        </p:nvSpPr>
        <p:spPr>
          <a:xfrm>
            <a:off x="3551803" y="326252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BA641DAF-6608-4C77-BE8C-6D17A4E45163}"/>
              </a:ext>
            </a:extLst>
          </p:cNvPr>
          <p:cNvSpPr txBox="1"/>
          <p:nvPr/>
        </p:nvSpPr>
        <p:spPr>
          <a:xfrm>
            <a:off x="4550442" y="810265"/>
            <a:ext cx="18809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LI 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≥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8 (n = 135): 4.4 (3.2-5.7) 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47C66029-2355-4CD8-BB26-E1FB5A0FDC8C}"/>
              </a:ext>
            </a:extLst>
          </p:cNvPr>
          <p:cNvSpPr txBox="1"/>
          <p:nvPr/>
        </p:nvSpPr>
        <p:spPr>
          <a:xfrm>
            <a:off x="4559818" y="980840"/>
            <a:ext cx="18809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LI &lt; 18 (n = 79)  : 3.3 (1.9-4.8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3736D343-3204-4CA7-B8FD-AF4641E2E699}"/>
              </a:ext>
            </a:extLst>
          </p:cNvPr>
          <p:cNvSpPr txBox="1"/>
          <p:nvPr/>
        </p:nvSpPr>
        <p:spPr>
          <a:xfrm>
            <a:off x="5223787" y="629064"/>
            <a:ext cx="11178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onths (95% CI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F95CBA3C-E637-4ED9-912E-B8E3A1584EE8}"/>
              </a:ext>
            </a:extLst>
          </p:cNvPr>
          <p:cNvSpPr txBox="1"/>
          <p:nvPr/>
        </p:nvSpPr>
        <p:spPr>
          <a:xfrm>
            <a:off x="4589687" y="1159551"/>
            <a:ext cx="11002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 = 0.06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2C02C6CE-47D5-4218-9E1A-9E26C1C9E996}"/>
              </a:ext>
            </a:extLst>
          </p:cNvPr>
          <p:cNvSpPr txBox="1"/>
          <p:nvPr/>
        </p:nvSpPr>
        <p:spPr>
          <a:xfrm rot="16200000">
            <a:off x="2864102" y="1304772"/>
            <a:ext cx="13452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urvival (PFS) probability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49467351-A9D9-4222-A7B5-48C84E515D28}"/>
              </a:ext>
            </a:extLst>
          </p:cNvPr>
          <p:cNvSpPr txBox="1"/>
          <p:nvPr/>
        </p:nvSpPr>
        <p:spPr>
          <a:xfrm>
            <a:off x="3535381" y="577076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0FACE509-8764-4694-AFA9-C9A95B377D01}"/>
              </a:ext>
            </a:extLst>
          </p:cNvPr>
          <p:cNvSpPr txBox="1"/>
          <p:nvPr/>
        </p:nvSpPr>
        <p:spPr>
          <a:xfrm>
            <a:off x="3535381" y="873764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2A55260C-4C73-43B3-9958-0171F5196652}"/>
              </a:ext>
            </a:extLst>
          </p:cNvPr>
          <p:cNvSpPr txBox="1"/>
          <p:nvPr/>
        </p:nvSpPr>
        <p:spPr>
          <a:xfrm>
            <a:off x="3535381" y="117045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2DE6E5FB-8E7A-4C8C-BFC1-6F09D58F08A1}"/>
              </a:ext>
            </a:extLst>
          </p:cNvPr>
          <p:cNvSpPr txBox="1"/>
          <p:nvPr/>
        </p:nvSpPr>
        <p:spPr>
          <a:xfrm>
            <a:off x="3535381" y="146714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D14B8CCF-651A-4155-A28D-E7246498C0A8}"/>
              </a:ext>
            </a:extLst>
          </p:cNvPr>
          <p:cNvSpPr txBox="1"/>
          <p:nvPr/>
        </p:nvSpPr>
        <p:spPr>
          <a:xfrm>
            <a:off x="3535381" y="1763832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BEE45358-9DE2-485F-9941-04337DD54E10}"/>
              </a:ext>
            </a:extLst>
          </p:cNvPr>
          <p:cNvSpPr txBox="1"/>
          <p:nvPr/>
        </p:nvSpPr>
        <p:spPr>
          <a:xfrm>
            <a:off x="3535381" y="2060520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A7C3E169-9096-42E6-9D6A-C332F0F6BA7B}"/>
              </a:ext>
            </a:extLst>
          </p:cNvPr>
          <p:cNvSpPr txBox="1"/>
          <p:nvPr/>
        </p:nvSpPr>
        <p:spPr>
          <a:xfrm>
            <a:off x="3769701" y="219104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2295D763-C16C-4134-8D32-9B6F5E172F1B}"/>
              </a:ext>
            </a:extLst>
          </p:cNvPr>
          <p:cNvSpPr txBox="1"/>
          <p:nvPr/>
        </p:nvSpPr>
        <p:spPr>
          <a:xfrm>
            <a:off x="4323816" y="219104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ED632884-EFBD-4036-9E66-D5DAB21AA7FD}"/>
              </a:ext>
            </a:extLst>
          </p:cNvPr>
          <p:cNvSpPr txBox="1"/>
          <p:nvPr/>
        </p:nvSpPr>
        <p:spPr>
          <a:xfrm>
            <a:off x="4911500" y="219104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964B229C-3E96-4791-A657-9EAFA966BD92}"/>
              </a:ext>
            </a:extLst>
          </p:cNvPr>
          <p:cNvSpPr txBox="1"/>
          <p:nvPr/>
        </p:nvSpPr>
        <p:spPr>
          <a:xfrm>
            <a:off x="5499185" y="219104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5AF3AD25-C44F-450F-B306-B27D393716EB}"/>
              </a:ext>
            </a:extLst>
          </p:cNvPr>
          <p:cNvSpPr txBox="1"/>
          <p:nvPr/>
        </p:nvSpPr>
        <p:spPr>
          <a:xfrm>
            <a:off x="5793026" y="219104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5A87A3BB-3342-4C18-B37A-6202C73CBF34}"/>
              </a:ext>
            </a:extLst>
          </p:cNvPr>
          <p:cNvSpPr txBox="1"/>
          <p:nvPr/>
        </p:nvSpPr>
        <p:spPr>
          <a:xfrm>
            <a:off x="6086872" y="2191042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3431D0B8-3CF4-47D4-AD93-A7BAB08EC34B}"/>
              </a:ext>
            </a:extLst>
          </p:cNvPr>
          <p:cNvSpPr txBox="1"/>
          <p:nvPr/>
        </p:nvSpPr>
        <p:spPr>
          <a:xfrm>
            <a:off x="4064380" y="219104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B16E68D5-C8EF-49D3-B7C0-CF4DD2868530}"/>
              </a:ext>
            </a:extLst>
          </p:cNvPr>
          <p:cNvSpPr txBox="1"/>
          <p:nvPr/>
        </p:nvSpPr>
        <p:spPr>
          <a:xfrm>
            <a:off x="4617659" y="219104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98512CE4-9A45-46C2-8E4F-73931E6493E0}"/>
              </a:ext>
            </a:extLst>
          </p:cNvPr>
          <p:cNvSpPr txBox="1"/>
          <p:nvPr/>
        </p:nvSpPr>
        <p:spPr>
          <a:xfrm>
            <a:off x="5205343" y="219104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9F14CB3A-3F71-4461-AF11-26A32CF9CE19}"/>
              </a:ext>
            </a:extLst>
          </p:cNvPr>
          <p:cNvSpPr txBox="1"/>
          <p:nvPr/>
        </p:nvSpPr>
        <p:spPr>
          <a:xfrm>
            <a:off x="4550599" y="2314972"/>
            <a:ext cx="10347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ime (months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6462F4A2-262B-4B7B-83CB-65A5F19CE00A}"/>
              </a:ext>
            </a:extLst>
          </p:cNvPr>
          <p:cNvSpPr txBox="1"/>
          <p:nvPr/>
        </p:nvSpPr>
        <p:spPr>
          <a:xfrm>
            <a:off x="3817897" y="326252"/>
            <a:ext cx="17674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Good PS patients (n = 224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E21BF072-0891-4BD4-816E-18BB43389BA8}"/>
              </a:ext>
            </a:extLst>
          </p:cNvPr>
          <p:cNvSpPr txBox="1"/>
          <p:nvPr/>
        </p:nvSpPr>
        <p:spPr>
          <a:xfrm>
            <a:off x="359353" y="2917115"/>
            <a:ext cx="3032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B8BEA9C8-F06B-4991-BD45-615BEF599F16}"/>
              </a:ext>
            </a:extLst>
          </p:cNvPr>
          <p:cNvSpPr txBox="1"/>
          <p:nvPr/>
        </p:nvSpPr>
        <p:spPr>
          <a:xfrm>
            <a:off x="1357992" y="3401128"/>
            <a:ext cx="18809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LI </a:t>
            </a:r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≥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8 (n = 26): 4.1 (1.6-6.8) 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4A740DAC-14C2-493A-B713-7E796A0E0540}"/>
              </a:ext>
            </a:extLst>
          </p:cNvPr>
          <p:cNvSpPr txBox="1"/>
          <p:nvPr/>
        </p:nvSpPr>
        <p:spPr>
          <a:xfrm>
            <a:off x="1367368" y="3571703"/>
            <a:ext cx="18809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LI &lt; 18 (n = 43): 0.9 (0.8-1.1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9F607966-0FE7-4AD4-96BC-65A72D6D3C5C}"/>
              </a:ext>
            </a:extLst>
          </p:cNvPr>
          <p:cNvSpPr txBox="1"/>
          <p:nvPr/>
        </p:nvSpPr>
        <p:spPr>
          <a:xfrm>
            <a:off x="1961487" y="3219927"/>
            <a:ext cx="11178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onths (95% CI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5F231EDF-3CB2-4B01-A57A-A347CF0954B7}"/>
              </a:ext>
            </a:extLst>
          </p:cNvPr>
          <p:cNvSpPr txBox="1"/>
          <p:nvPr/>
        </p:nvSpPr>
        <p:spPr>
          <a:xfrm>
            <a:off x="1397237" y="3750414"/>
            <a:ext cx="11002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 = 0.00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0F5B8371-3B85-4803-B37A-6AC61394246B}"/>
              </a:ext>
            </a:extLst>
          </p:cNvPr>
          <p:cNvSpPr txBox="1"/>
          <p:nvPr/>
        </p:nvSpPr>
        <p:spPr>
          <a:xfrm rot="16200000">
            <a:off x="-328348" y="3895635"/>
            <a:ext cx="13452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urvival (PFS) probability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723630C7-44CD-402B-98BA-3058016D89E3}"/>
              </a:ext>
            </a:extLst>
          </p:cNvPr>
          <p:cNvSpPr txBox="1"/>
          <p:nvPr/>
        </p:nvSpPr>
        <p:spPr>
          <a:xfrm>
            <a:off x="342931" y="3167939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514D5D63-00AC-46D8-904C-52A9875292A4}"/>
              </a:ext>
            </a:extLst>
          </p:cNvPr>
          <p:cNvSpPr txBox="1"/>
          <p:nvPr/>
        </p:nvSpPr>
        <p:spPr>
          <a:xfrm>
            <a:off x="342931" y="3464627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618515F6-CF87-465B-8FFE-068A1D36E3C1}"/>
              </a:ext>
            </a:extLst>
          </p:cNvPr>
          <p:cNvSpPr txBox="1"/>
          <p:nvPr/>
        </p:nvSpPr>
        <p:spPr>
          <a:xfrm>
            <a:off x="342931" y="3761316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77C25FD1-E877-4910-A233-06DCB2EAB696}"/>
              </a:ext>
            </a:extLst>
          </p:cNvPr>
          <p:cNvSpPr txBox="1"/>
          <p:nvPr/>
        </p:nvSpPr>
        <p:spPr>
          <a:xfrm>
            <a:off x="342931" y="4058006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FCA1A7B5-10DD-4EC8-8EFB-502E7F554818}"/>
              </a:ext>
            </a:extLst>
          </p:cNvPr>
          <p:cNvSpPr txBox="1"/>
          <p:nvPr/>
        </p:nvSpPr>
        <p:spPr>
          <a:xfrm>
            <a:off x="342931" y="4354695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2C87944F-01A1-4AE9-98BC-35982C4C0781}"/>
              </a:ext>
            </a:extLst>
          </p:cNvPr>
          <p:cNvSpPr txBox="1"/>
          <p:nvPr/>
        </p:nvSpPr>
        <p:spPr>
          <a:xfrm>
            <a:off x="342931" y="465138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8F447A84-D243-4A33-B677-CDDB6581CE7D}"/>
              </a:ext>
            </a:extLst>
          </p:cNvPr>
          <p:cNvSpPr txBox="1"/>
          <p:nvPr/>
        </p:nvSpPr>
        <p:spPr>
          <a:xfrm>
            <a:off x="577251" y="478190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29BFF777-B325-4BB6-BC6C-88A7BE85CD66}"/>
              </a:ext>
            </a:extLst>
          </p:cNvPr>
          <p:cNvSpPr txBox="1"/>
          <p:nvPr/>
        </p:nvSpPr>
        <p:spPr>
          <a:xfrm>
            <a:off x="1131366" y="478190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0688F777-E309-4884-9AE1-CF7E03FD456C}"/>
              </a:ext>
            </a:extLst>
          </p:cNvPr>
          <p:cNvSpPr txBox="1"/>
          <p:nvPr/>
        </p:nvSpPr>
        <p:spPr>
          <a:xfrm>
            <a:off x="1719050" y="478190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34BE1C15-BF6F-4FAD-9416-270195B8F29B}"/>
              </a:ext>
            </a:extLst>
          </p:cNvPr>
          <p:cNvSpPr txBox="1"/>
          <p:nvPr/>
        </p:nvSpPr>
        <p:spPr>
          <a:xfrm>
            <a:off x="2306735" y="478190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CEF32638-F153-463C-8A10-ACC6282D7F46}"/>
              </a:ext>
            </a:extLst>
          </p:cNvPr>
          <p:cNvSpPr txBox="1"/>
          <p:nvPr/>
        </p:nvSpPr>
        <p:spPr>
          <a:xfrm>
            <a:off x="2600576" y="478190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220243AE-8B54-42EF-8004-7F75B20E2D5E}"/>
              </a:ext>
            </a:extLst>
          </p:cNvPr>
          <p:cNvSpPr txBox="1"/>
          <p:nvPr/>
        </p:nvSpPr>
        <p:spPr>
          <a:xfrm>
            <a:off x="2894422" y="4781905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4CD713F3-CBCD-4293-ADDB-1829A31A2F39}"/>
              </a:ext>
            </a:extLst>
          </p:cNvPr>
          <p:cNvSpPr txBox="1"/>
          <p:nvPr/>
        </p:nvSpPr>
        <p:spPr>
          <a:xfrm>
            <a:off x="871930" y="478190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id="{FF2412C6-1406-4987-94FB-73CD8C303992}"/>
              </a:ext>
            </a:extLst>
          </p:cNvPr>
          <p:cNvSpPr txBox="1"/>
          <p:nvPr/>
        </p:nvSpPr>
        <p:spPr>
          <a:xfrm>
            <a:off x="1425209" y="478190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id="{0CA125F5-E262-413B-AC15-99CE0B956810}"/>
              </a:ext>
            </a:extLst>
          </p:cNvPr>
          <p:cNvSpPr txBox="1"/>
          <p:nvPr/>
        </p:nvSpPr>
        <p:spPr>
          <a:xfrm>
            <a:off x="2012893" y="478190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04F94211-8382-484C-BD42-452444344F4E}"/>
              </a:ext>
            </a:extLst>
          </p:cNvPr>
          <p:cNvSpPr txBox="1"/>
          <p:nvPr/>
        </p:nvSpPr>
        <p:spPr>
          <a:xfrm>
            <a:off x="1358149" y="4905835"/>
            <a:ext cx="10347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ime (months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E37E46A1-5E90-4F4C-A515-C58804B0CD8F}"/>
              </a:ext>
            </a:extLst>
          </p:cNvPr>
          <p:cNvSpPr txBox="1"/>
          <p:nvPr/>
        </p:nvSpPr>
        <p:spPr>
          <a:xfrm>
            <a:off x="625447" y="2917115"/>
            <a:ext cx="18889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oor PS patients (n = 59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68221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04</Words>
  <Application>Microsoft Office PowerPoint</Application>
  <PresentationFormat>A4 210 x 297 mm</PresentationFormat>
  <Paragraphs>6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足立　雄一／Adachi,Yuichi</dc:creator>
  <cp:lastModifiedBy>足立　雄一／Adachi,Yuichi</cp:lastModifiedBy>
  <cp:revision>30</cp:revision>
  <dcterms:created xsi:type="dcterms:W3CDTF">2019-07-26T07:06:04Z</dcterms:created>
  <dcterms:modified xsi:type="dcterms:W3CDTF">2019-12-08T15:19:59Z</dcterms:modified>
</cp:coreProperties>
</file>